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5" d="100"/>
          <a:sy n="75" d="100"/>
        </p:scale>
        <p:origin x="138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2408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287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6201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7534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4703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2344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7036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4153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2146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3736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6670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CE44A6-2342-4A93-B2DA-B7B460F8E5D1}" type="datetimeFigureOut">
              <a:rPr lang="en-GB" smtClean="0"/>
              <a:t>0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5A2F5B-B5BE-46E2-8B86-54AD1F584D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4425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48054" y="275963"/>
            <a:ext cx="5997162" cy="9747386"/>
            <a:chOff x="248054" y="275963"/>
            <a:chExt cx="5997162" cy="9747386"/>
          </a:xfrm>
        </p:grpSpPr>
        <p:grpSp>
          <p:nvGrpSpPr>
            <p:cNvPr id="5" name="Group 4"/>
            <p:cNvGrpSpPr/>
            <p:nvPr/>
          </p:nvGrpSpPr>
          <p:grpSpPr>
            <a:xfrm>
              <a:off x="248054" y="275963"/>
              <a:ext cx="5997162" cy="9747386"/>
              <a:chOff x="248054" y="379199"/>
              <a:chExt cx="5997162" cy="9747386"/>
            </a:xfrm>
          </p:grpSpPr>
          <p:grpSp>
            <p:nvGrpSpPr>
              <p:cNvPr id="17" name="Group 16"/>
              <p:cNvGrpSpPr/>
              <p:nvPr/>
            </p:nvGrpSpPr>
            <p:grpSpPr>
              <a:xfrm>
                <a:off x="255860" y="6063566"/>
                <a:ext cx="2150744" cy="2150744"/>
                <a:chOff x="3437934" y="5640863"/>
                <a:chExt cx="2150744" cy="2150744"/>
              </a:xfrm>
            </p:grpSpPr>
            <p:pic>
              <p:nvPicPr>
                <p:cNvPr id="124" name="Picture 123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437934" y="5640863"/>
                  <a:ext cx="2007621" cy="2007621"/>
                </a:xfrm>
                <a:prstGeom prst="rect">
                  <a:avLst/>
                </a:prstGeom>
              </p:spPr>
            </p:pic>
            <p:sp>
              <p:nvSpPr>
                <p:cNvPr id="125" name="Rectangle 124"/>
                <p:cNvSpPr/>
                <p:nvPr/>
              </p:nvSpPr>
              <p:spPr>
                <a:xfrm>
                  <a:off x="3967910" y="5896070"/>
                  <a:ext cx="605484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: 3.37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6" name="Rectangle 125"/>
                <p:cNvSpPr/>
                <p:nvPr/>
              </p:nvSpPr>
              <p:spPr>
                <a:xfrm>
                  <a:off x="4116535" y="7026754"/>
                  <a:ext cx="566343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53.99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7" name="Isosceles Triangle 126"/>
                <p:cNvSpPr/>
                <p:nvPr/>
              </p:nvSpPr>
              <p:spPr>
                <a:xfrm flipV="1">
                  <a:off x="3854935" y="5945088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pic>
              <p:nvPicPr>
                <p:cNvPr id="128" name="Picture 127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581057" y="5783986"/>
                  <a:ext cx="2007621" cy="2007621"/>
                </a:xfrm>
                <a:prstGeom prst="rect">
                  <a:avLst/>
                </a:prstGeom>
              </p:spPr>
            </p:pic>
            <p:sp>
              <p:nvSpPr>
                <p:cNvPr id="129" name="Isosceles Triangle 128"/>
                <p:cNvSpPr/>
                <p:nvPr/>
              </p:nvSpPr>
              <p:spPr>
                <a:xfrm flipV="1">
                  <a:off x="4382041" y="7372559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30" name="Rectangle 129"/>
                <p:cNvSpPr/>
                <p:nvPr/>
              </p:nvSpPr>
              <p:spPr>
                <a:xfrm>
                  <a:off x="4126259" y="6075617"/>
                  <a:ext cx="732893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3.37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1" name="Rectangle 130"/>
                <p:cNvSpPr/>
                <p:nvPr/>
              </p:nvSpPr>
              <p:spPr>
                <a:xfrm>
                  <a:off x="4259659" y="7169878"/>
                  <a:ext cx="688009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53.99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2" name="Isosceles Triangle 131"/>
                <p:cNvSpPr/>
                <p:nvPr/>
              </p:nvSpPr>
              <p:spPr>
                <a:xfrm flipV="1">
                  <a:off x="3998059" y="6088211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18" name="Group 17"/>
              <p:cNvGrpSpPr/>
              <p:nvPr/>
            </p:nvGrpSpPr>
            <p:grpSpPr>
              <a:xfrm>
                <a:off x="248054" y="379199"/>
                <a:ext cx="2134498" cy="2134499"/>
                <a:chOff x="1691817" y="157199"/>
                <a:chExt cx="2134498" cy="2134499"/>
              </a:xfrm>
            </p:grpSpPr>
            <p:pic>
              <p:nvPicPr>
                <p:cNvPr id="114" name="Picture 113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691817" y="157199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115" name="Rectangle 114"/>
                <p:cNvSpPr/>
                <p:nvPr/>
              </p:nvSpPr>
              <p:spPr>
                <a:xfrm>
                  <a:off x="2878125" y="514839"/>
                  <a:ext cx="506126" cy="16060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3.17</a:t>
                  </a:r>
                </a:p>
              </p:txBody>
            </p:sp>
            <p:sp>
              <p:nvSpPr>
                <p:cNvPr id="116" name="Rectangle 115"/>
                <p:cNvSpPr/>
                <p:nvPr/>
              </p:nvSpPr>
              <p:spPr>
                <a:xfrm>
                  <a:off x="2437521" y="876894"/>
                  <a:ext cx="588924" cy="3342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 </a:t>
                  </a: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.55</a:t>
                  </a:r>
                </a:p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7" name="Isosceles Triangle 116"/>
                <p:cNvSpPr/>
                <p:nvPr/>
              </p:nvSpPr>
              <p:spPr>
                <a:xfrm flipV="1">
                  <a:off x="3106217" y="648791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18" name="Isosceles Triangle 117"/>
                <p:cNvSpPr/>
                <p:nvPr/>
              </p:nvSpPr>
              <p:spPr>
                <a:xfrm flipV="1">
                  <a:off x="2603999" y="1022493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pic>
              <p:nvPicPr>
                <p:cNvPr id="119" name="Picture 118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834940" y="300323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120" name="Rectangle 119"/>
                <p:cNvSpPr/>
                <p:nvPr/>
              </p:nvSpPr>
              <p:spPr>
                <a:xfrm>
                  <a:off x="3021249" y="628466"/>
                  <a:ext cx="611065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3.17</a:t>
                  </a:r>
                </a:p>
              </p:txBody>
            </p:sp>
            <p:sp>
              <p:nvSpPr>
                <p:cNvPr id="121" name="Rectangle 120"/>
                <p:cNvSpPr/>
                <p:nvPr/>
              </p:nvSpPr>
              <p:spPr>
                <a:xfrm>
                  <a:off x="2529026" y="1020017"/>
                  <a:ext cx="732893" cy="38818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</a:t>
                  </a: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.55</a:t>
                  </a:r>
                </a:p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Isosceles Triangle 121"/>
                <p:cNvSpPr/>
                <p:nvPr/>
              </p:nvSpPr>
              <p:spPr>
                <a:xfrm flipV="1">
                  <a:off x="3249340" y="791914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23" name="Isosceles Triangle 122"/>
                <p:cNvSpPr/>
                <p:nvPr/>
              </p:nvSpPr>
              <p:spPr>
                <a:xfrm flipV="1">
                  <a:off x="2747123" y="1165616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19" name="Group 18"/>
              <p:cNvGrpSpPr/>
              <p:nvPr/>
            </p:nvGrpSpPr>
            <p:grpSpPr>
              <a:xfrm>
                <a:off x="273330" y="2368475"/>
                <a:ext cx="2134498" cy="2134498"/>
                <a:chOff x="1691817" y="5633870"/>
                <a:chExt cx="2134498" cy="2134498"/>
              </a:xfrm>
            </p:grpSpPr>
            <p:pic>
              <p:nvPicPr>
                <p:cNvPr id="106" name="Picture 105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691817" y="5633870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107" name="Rectangle 106"/>
                <p:cNvSpPr/>
                <p:nvPr/>
              </p:nvSpPr>
              <p:spPr>
                <a:xfrm>
                  <a:off x="2200668" y="5896535"/>
                  <a:ext cx="635593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: 58.77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8" name="Rectangle 107"/>
                <p:cNvSpPr/>
                <p:nvPr/>
              </p:nvSpPr>
              <p:spPr>
                <a:xfrm>
                  <a:off x="2208372" y="5972270"/>
                  <a:ext cx="566343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67.70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09" name="Picture 108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834940" y="5776993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110" name="Isosceles Triangle 109"/>
                <p:cNvSpPr/>
                <p:nvPr/>
              </p:nvSpPr>
              <p:spPr>
                <a:xfrm flipV="1">
                  <a:off x="2321132" y="6081851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11" name="Rectangle 110"/>
                <p:cNvSpPr/>
                <p:nvPr/>
              </p:nvSpPr>
              <p:spPr>
                <a:xfrm>
                  <a:off x="2343792" y="6039659"/>
                  <a:ext cx="771365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58.77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2" name="Rectangle 111"/>
                <p:cNvSpPr/>
                <p:nvPr/>
              </p:nvSpPr>
              <p:spPr>
                <a:xfrm>
                  <a:off x="2351495" y="6115393"/>
                  <a:ext cx="688009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67.70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Isosceles Triangle 112"/>
                <p:cNvSpPr/>
                <p:nvPr/>
              </p:nvSpPr>
              <p:spPr>
                <a:xfrm flipV="1">
                  <a:off x="2247772" y="6082665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20" name="Group 19"/>
              <p:cNvGrpSpPr/>
              <p:nvPr/>
            </p:nvGrpSpPr>
            <p:grpSpPr>
              <a:xfrm>
                <a:off x="4062884" y="425134"/>
                <a:ext cx="2134498" cy="2134498"/>
                <a:chOff x="1691817" y="3802645"/>
                <a:chExt cx="2134498" cy="2134498"/>
              </a:xfrm>
            </p:grpSpPr>
            <p:pic>
              <p:nvPicPr>
                <p:cNvPr id="97" name="Picture 96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691817" y="3802645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98" name="Isosceles Triangle 97"/>
                <p:cNvSpPr/>
                <p:nvPr/>
              </p:nvSpPr>
              <p:spPr>
                <a:xfrm flipV="1">
                  <a:off x="2201419" y="4106737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99" name="Rectangle 98"/>
                <p:cNvSpPr/>
                <p:nvPr/>
              </p:nvSpPr>
              <p:spPr>
                <a:xfrm>
                  <a:off x="2298918" y="4079830"/>
                  <a:ext cx="605484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: 8.63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0" name="Rectangle 99"/>
                <p:cNvSpPr/>
                <p:nvPr/>
              </p:nvSpPr>
              <p:spPr>
                <a:xfrm>
                  <a:off x="2301334" y="4158175"/>
                  <a:ext cx="536234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4.92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01" name="Picture 100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834940" y="3945768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102" name="Isosceles Triangle 101"/>
                <p:cNvSpPr/>
                <p:nvPr/>
              </p:nvSpPr>
              <p:spPr>
                <a:xfrm flipV="1">
                  <a:off x="2344543" y="4249861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03" name="Rectangle 102"/>
                <p:cNvSpPr/>
                <p:nvPr/>
              </p:nvSpPr>
              <p:spPr>
                <a:xfrm>
                  <a:off x="2442042" y="4222954"/>
                  <a:ext cx="732893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8.63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4" name="Isosceles Triangle 103"/>
                <p:cNvSpPr/>
                <p:nvPr/>
              </p:nvSpPr>
              <p:spPr>
                <a:xfrm flipV="1">
                  <a:off x="2291403" y="4251730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05" name="Rectangle 104"/>
                <p:cNvSpPr/>
                <p:nvPr/>
              </p:nvSpPr>
              <p:spPr>
                <a:xfrm>
                  <a:off x="2444458" y="4316046"/>
                  <a:ext cx="649537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4.92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1" name="Group 20"/>
              <p:cNvGrpSpPr/>
              <p:nvPr/>
            </p:nvGrpSpPr>
            <p:grpSpPr>
              <a:xfrm>
                <a:off x="2251878" y="415532"/>
                <a:ext cx="2134498" cy="2134499"/>
                <a:chOff x="1691817" y="1971420"/>
                <a:chExt cx="2134498" cy="2134499"/>
              </a:xfrm>
            </p:grpSpPr>
            <p:pic>
              <p:nvPicPr>
                <p:cNvPr id="87" name="Picture 86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691817" y="1971420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88" name="Isosceles Triangle 87"/>
                <p:cNvSpPr/>
                <p:nvPr/>
              </p:nvSpPr>
              <p:spPr>
                <a:xfrm flipV="1">
                  <a:off x="2804745" y="2496533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89" name="Rectangle 88"/>
                <p:cNvSpPr/>
                <p:nvPr/>
              </p:nvSpPr>
              <p:spPr>
                <a:xfrm>
                  <a:off x="2727749" y="2363336"/>
                  <a:ext cx="506126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.28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Isosceles Triangle 89"/>
                <p:cNvSpPr/>
                <p:nvPr/>
              </p:nvSpPr>
              <p:spPr>
                <a:xfrm flipV="1">
                  <a:off x="2742684" y="2496533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91" name="Rectangle 90"/>
                <p:cNvSpPr/>
                <p:nvPr/>
              </p:nvSpPr>
              <p:spPr>
                <a:xfrm>
                  <a:off x="2202704" y="2370000"/>
                  <a:ext cx="605484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: 1.21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92" name="Picture 91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834940" y="2114544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93" name="Isosceles Triangle 92"/>
                <p:cNvSpPr/>
                <p:nvPr/>
              </p:nvSpPr>
              <p:spPr>
                <a:xfrm flipV="1">
                  <a:off x="2796532" y="2485525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94" name="Rectangle 93"/>
                <p:cNvSpPr/>
                <p:nvPr/>
              </p:nvSpPr>
              <p:spPr>
                <a:xfrm>
                  <a:off x="2793275" y="2361094"/>
                  <a:ext cx="611065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.28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" name="Isosceles Triangle 94"/>
                <p:cNvSpPr/>
                <p:nvPr/>
              </p:nvSpPr>
              <p:spPr>
                <a:xfrm flipV="1">
                  <a:off x="2734470" y="2485525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96" name="Rectangle 95"/>
                <p:cNvSpPr/>
                <p:nvPr/>
              </p:nvSpPr>
              <p:spPr>
                <a:xfrm>
                  <a:off x="2083880" y="2367758"/>
                  <a:ext cx="732893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1.21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2" name="Group 21"/>
              <p:cNvGrpSpPr/>
              <p:nvPr/>
            </p:nvGrpSpPr>
            <p:grpSpPr>
              <a:xfrm>
                <a:off x="393054" y="4365100"/>
                <a:ext cx="2007621" cy="2007621"/>
                <a:chOff x="3581057" y="320930"/>
                <a:chExt cx="2007621" cy="2007621"/>
              </a:xfrm>
            </p:grpSpPr>
            <p:sp>
              <p:nvSpPr>
                <p:cNvPr id="78" name="Rectangle 77"/>
                <p:cNvSpPr/>
                <p:nvPr/>
              </p:nvSpPr>
              <p:spPr>
                <a:xfrm>
                  <a:off x="4820562" y="977636"/>
                  <a:ext cx="430855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4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Rectangle 78"/>
                <p:cNvSpPr/>
                <p:nvPr/>
              </p:nvSpPr>
              <p:spPr>
                <a:xfrm>
                  <a:off x="4156078" y="443718"/>
                  <a:ext cx="530213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Isosceles Triangle 79"/>
                <p:cNvSpPr/>
                <p:nvPr/>
              </p:nvSpPr>
              <p:spPr>
                <a:xfrm flipV="1">
                  <a:off x="5106012" y="1108200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81" name="Isosceles Triangle 80"/>
                <p:cNvSpPr/>
                <p:nvPr/>
              </p:nvSpPr>
              <p:spPr>
                <a:xfrm flipV="1">
                  <a:off x="4159614" y="485418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pic>
              <p:nvPicPr>
                <p:cNvPr id="82" name="Picture 81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581057" y="320930"/>
                  <a:ext cx="2007621" cy="2007621"/>
                </a:xfrm>
                <a:prstGeom prst="rect">
                  <a:avLst/>
                </a:prstGeom>
              </p:spPr>
            </p:pic>
            <p:sp>
              <p:nvSpPr>
                <p:cNvPr id="83" name="Rectangle 82"/>
                <p:cNvSpPr/>
                <p:nvPr/>
              </p:nvSpPr>
              <p:spPr>
                <a:xfrm>
                  <a:off x="4854011" y="1076008"/>
                  <a:ext cx="514885" cy="1911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4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Rectangle 83"/>
                <p:cNvSpPr/>
                <p:nvPr/>
              </p:nvSpPr>
              <p:spPr>
                <a:xfrm>
                  <a:off x="4342374" y="594251"/>
                  <a:ext cx="636713" cy="1911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1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Isosceles Triangle 84"/>
                <p:cNvSpPr/>
                <p:nvPr/>
              </p:nvSpPr>
              <p:spPr>
                <a:xfrm flipV="1">
                  <a:off x="5249136" y="1251323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86" name="Isosceles Triangle 85"/>
                <p:cNvSpPr/>
                <p:nvPr/>
              </p:nvSpPr>
              <p:spPr>
                <a:xfrm flipV="1">
                  <a:off x="4302737" y="628541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23" name="Group 22"/>
              <p:cNvGrpSpPr/>
              <p:nvPr/>
            </p:nvGrpSpPr>
            <p:grpSpPr>
              <a:xfrm>
                <a:off x="2179959" y="4254398"/>
                <a:ext cx="2150744" cy="2150745"/>
                <a:chOff x="3437934" y="1984655"/>
                <a:chExt cx="2150744" cy="2150745"/>
              </a:xfrm>
            </p:grpSpPr>
            <p:pic>
              <p:nvPicPr>
                <p:cNvPr id="68" name="Picture 67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437934" y="1984655"/>
                  <a:ext cx="2007621" cy="2007621"/>
                </a:xfrm>
                <a:prstGeom prst="rect">
                  <a:avLst/>
                </a:prstGeom>
              </p:spPr>
            </p:pic>
            <p:sp>
              <p:nvSpPr>
                <p:cNvPr id="69" name="Isosceles Triangle 68"/>
                <p:cNvSpPr/>
                <p:nvPr/>
              </p:nvSpPr>
              <p:spPr>
                <a:xfrm flipV="1">
                  <a:off x="4166740" y="3560251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0" name="Rectangle 69"/>
                <p:cNvSpPr/>
                <p:nvPr/>
              </p:nvSpPr>
              <p:spPr>
                <a:xfrm>
                  <a:off x="3740558" y="3248743"/>
                  <a:ext cx="605484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: 1.68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Isosceles Triangle 70"/>
                <p:cNvSpPr/>
                <p:nvPr/>
              </p:nvSpPr>
              <p:spPr>
                <a:xfrm flipV="1">
                  <a:off x="4608799" y="3138882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2" name="Rectangle 71"/>
                <p:cNvSpPr/>
                <p:nvPr/>
              </p:nvSpPr>
              <p:spPr>
                <a:xfrm>
                  <a:off x="4509004" y="2992291"/>
                  <a:ext cx="506126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3.77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73" name="Picture 72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581057" y="2127779"/>
                  <a:ext cx="2007621" cy="2007621"/>
                </a:xfrm>
                <a:prstGeom prst="rect">
                  <a:avLst/>
                </a:prstGeom>
              </p:spPr>
            </p:pic>
            <p:sp>
              <p:nvSpPr>
                <p:cNvPr id="74" name="Isosceles Triangle 73"/>
                <p:cNvSpPr/>
                <p:nvPr/>
              </p:nvSpPr>
              <p:spPr>
                <a:xfrm flipV="1">
                  <a:off x="4309864" y="3703375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5" name="Rectangle 74"/>
                <p:cNvSpPr/>
                <p:nvPr/>
              </p:nvSpPr>
              <p:spPr>
                <a:xfrm>
                  <a:off x="3854587" y="3361601"/>
                  <a:ext cx="732893" cy="1911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1.68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Isosceles Triangle 75"/>
                <p:cNvSpPr/>
                <p:nvPr/>
              </p:nvSpPr>
              <p:spPr>
                <a:xfrm flipV="1">
                  <a:off x="4751923" y="3282006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7" name="Rectangle 76"/>
                <p:cNvSpPr/>
                <p:nvPr/>
              </p:nvSpPr>
              <p:spPr>
                <a:xfrm>
                  <a:off x="4652128" y="3135415"/>
                  <a:ext cx="611065" cy="1911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3.77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4" name="Group 23"/>
              <p:cNvGrpSpPr/>
              <p:nvPr/>
            </p:nvGrpSpPr>
            <p:grpSpPr>
              <a:xfrm>
                <a:off x="4207863" y="4418671"/>
                <a:ext cx="2007621" cy="2007621"/>
                <a:chOff x="3581057" y="3960133"/>
                <a:chExt cx="2007621" cy="2007621"/>
              </a:xfrm>
            </p:grpSpPr>
            <p:sp>
              <p:nvSpPr>
                <p:cNvPr id="59" name="Isosceles Triangle 58"/>
                <p:cNvSpPr/>
                <p:nvPr/>
              </p:nvSpPr>
              <p:spPr>
                <a:xfrm flipV="1">
                  <a:off x="4199780" y="5240731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0" name="Rectangle 59"/>
                <p:cNvSpPr/>
                <p:nvPr/>
              </p:nvSpPr>
              <p:spPr>
                <a:xfrm>
                  <a:off x="3882129" y="4084073"/>
                  <a:ext cx="605484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: 3.37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Isosceles Triangle 60"/>
                <p:cNvSpPr/>
                <p:nvPr/>
              </p:nvSpPr>
              <p:spPr>
                <a:xfrm flipV="1">
                  <a:off x="3908259" y="4133586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2" name="Rectangle 61"/>
                <p:cNvSpPr/>
                <p:nvPr/>
              </p:nvSpPr>
              <p:spPr>
                <a:xfrm>
                  <a:off x="4079217" y="5084003"/>
                  <a:ext cx="536234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7.53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63" name="Picture 62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3581057" y="3960133"/>
                  <a:ext cx="2007621" cy="2007621"/>
                </a:xfrm>
                <a:prstGeom prst="rect">
                  <a:avLst/>
                </a:prstGeom>
              </p:spPr>
            </p:pic>
            <p:sp>
              <p:nvSpPr>
                <p:cNvPr id="64" name="Isosceles Triangle 63"/>
                <p:cNvSpPr/>
                <p:nvPr/>
              </p:nvSpPr>
              <p:spPr>
                <a:xfrm flipV="1">
                  <a:off x="4342903" y="5383854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5" name="Rectangle 64"/>
                <p:cNvSpPr/>
                <p:nvPr/>
              </p:nvSpPr>
              <p:spPr>
                <a:xfrm>
                  <a:off x="4071693" y="4214865"/>
                  <a:ext cx="732893" cy="1911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3.37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Isosceles Triangle 65"/>
                <p:cNvSpPr/>
                <p:nvPr/>
              </p:nvSpPr>
              <p:spPr>
                <a:xfrm flipV="1">
                  <a:off x="4051383" y="4276710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7" name="Rectangle 66"/>
                <p:cNvSpPr/>
                <p:nvPr/>
              </p:nvSpPr>
              <p:spPr>
                <a:xfrm>
                  <a:off x="4222340" y="5227126"/>
                  <a:ext cx="649537" cy="19114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7.53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5" name="Group 24"/>
              <p:cNvGrpSpPr/>
              <p:nvPr/>
            </p:nvGrpSpPr>
            <p:grpSpPr>
              <a:xfrm>
                <a:off x="2335583" y="6225130"/>
                <a:ext cx="2007621" cy="2007621"/>
                <a:chOff x="3581057" y="7607840"/>
                <a:chExt cx="2007621" cy="2007621"/>
              </a:xfrm>
            </p:grpSpPr>
            <p:sp>
              <p:nvSpPr>
                <p:cNvPr id="52" name="Isosceles Triangle 51"/>
                <p:cNvSpPr/>
                <p:nvPr/>
              </p:nvSpPr>
              <p:spPr>
                <a:xfrm flipV="1">
                  <a:off x="4753439" y="8138937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3" name="Rectangle 52"/>
                <p:cNvSpPr/>
                <p:nvPr/>
              </p:nvSpPr>
              <p:spPr>
                <a:xfrm>
                  <a:off x="4679437" y="8010190"/>
                  <a:ext cx="536234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88.46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54" name="Picture 53"/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3581057" y="7607840"/>
                  <a:ext cx="2007621" cy="2007621"/>
                </a:xfrm>
                <a:prstGeom prst="rect">
                  <a:avLst/>
                </a:prstGeom>
              </p:spPr>
            </p:pic>
            <p:sp>
              <p:nvSpPr>
                <p:cNvPr id="55" name="Isosceles Triangle 54"/>
                <p:cNvSpPr/>
                <p:nvPr/>
              </p:nvSpPr>
              <p:spPr>
                <a:xfrm flipV="1">
                  <a:off x="4059248" y="7911143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6" name="Isosceles Triangle 55"/>
                <p:cNvSpPr/>
                <p:nvPr/>
              </p:nvSpPr>
              <p:spPr>
                <a:xfrm flipV="1">
                  <a:off x="4896562" y="8282061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7" name="Rectangle 56"/>
                <p:cNvSpPr/>
                <p:nvPr/>
              </p:nvSpPr>
              <p:spPr>
                <a:xfrm>
                  <a:off x="4049784" y="7877431"/>
                  <a:ext cx="732893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8.35</a:t>
                  </a:r>
                </a:p>
              </p:txBody>
            </p:sp>
            <p:sp>
              <p:nvSpPr>
                <p:cNvPr id="58" name="Rectangle 57"/>
                <p:cNvSpPr/>
                <p:nvPr/>
              </p:nvSpPr>
              <p:spPr>
                <a:xfrm>
                  <a:off x="4639685" y="8138565"/>
                  <a:ext cx="649537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88.46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6" name="Group 25"/>
              <p:cNvGrpSpPr/>
              <p:nvPr/>
            </p:nvGrpSpPr>
            <p:grpSpPr>
              <a:xfrm>
                <a:off x="4237595" y="6232184"/>
                <a:ext cx="2007621" cy="2007621"/>
                <a:chOff x="5203851" y="7628989"/>
                <a:chExt cx="2007621" cy="2007621"/>
              </a:xfrm>
            </p:grpSpPr>
            <p:sp>
              <p:nvSpPr>
                <p:cNvPr id="43" name="Isosceles Triangle 42"/>
                <p:cNvSpPr/>
                <p:nvPr/>
              </p:nvSpPr>
              <p:spPr>
                <a:xfrm flipV="1">
                  <a:off x="5499395" y="7794391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4" name="Rectangle 43"/>
                <p:cNvSpPr/>
                <p:nvPr/>
              </p:nvSpPr>
              <p:spPr>
                <a:xfrm>
                  <a:off x="5486189" y="7741638"/>
                  <a:ext cx="536234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88.46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Isosceles Triangle 44"/>
                <p:cNvSpPr/>
                <p:nvPr/>
              </p:nvSpPr>
              <p:spPr>
                <a:xfrm flipV="1">
                  <a:off x="6530204" y="8831919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6" name="Rectangle 45"/>
                <p:cNvSpPr/>
                <p:nvPr/>
              </p:nvSpPr>
              <p:spPr>
                <a:xfrm>
                  <a:off x="6520741" y="8815212"/>
                  <a:ext cx="635593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: 84.44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47" name="Picture 46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5203851" y="7628989"/>
                  <a:ext cx="2007621" cy="2007621"/>
                </a:xfrm>
                <a:prstGeom prst="rect">
                  <a:avLst/>
                </a:prstGeom>
              </p:spPr>
            </p:pic>
            <p:sp>
              <p:nvSpPr>
                <p:cNvPr id="48" name="Isosceles Triangle 47"/>
                <p:cNvSpPr/>
                <p:nvPr/>
              </p:nvSpPr>
              <p:spPr>
                <a:xfrm flipV="1">
                  <a:off x="5642519" y="7937514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9" name="Rectangle 48"/>
                <p:cNvSpPr/>
                <p:nvPr/>
              </p:nvSpPr>
              <p:spPr>
                <a:xfrm>
                  <a:off x="5688713" y="7873792"/>
                  <a:ext cx="611065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3.15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Isosceles Triangle 49"/>
                <p:cNvSpPr/>
                <p:nvPr/>
              </p:nvSpPr>
              <p:spPr>
                <a:xfrm flipV="1">
                  <a:off x="6673328" y="8975043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1" name="Rectangle 50"/>
                <p:cNvSpPr/>
                <p:nvPr/>
              </p:nvSpPr>
              <p:spPr>
                <a:xfrm>
                  <a:off x="6375633" y="8769495"/>
                  <a:ext cx="771365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84.44</a:t>
                  </a:r>
                </a:p>
              </p:txBody>
            </p:sp>
          </p:grpSp>
          <p:sp>
            <p:nvSpPr>
              <p:cNvPr id="27" name="TextBox 26"/>
              <p:cNvSpPr txBox="1"/>
              <p:nvPr/>
            </p:nvSpPr>
            <p:spPr>
              <a:xfrm>
                <a:off x="440265" y="8140785"/>
                <a:ext cx="5705953" cy="19858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GB" sz="1100" b="1" dirty="0"/>
                  <a:t>Supplementary file </a:t>
                </a:r>
                <a:r>
                  <a:rPr lang="en-GB" sz="1100" b="1" dirty="0" smtClean="0"/>
                  <a:t>S4 </a:t>
                </a:r>
                <a:r>
                  <a:rPr lang="en-GB" sz="1100" b="1" dirty="0"/>
                  <a:t>Phenotypic variation </a:t>
                </a:r>
                <a:r>
                  <a:rPr lang="en-GB" sz="1100" b="1" dirty="0" smtClean="0"/>
                  <a:t>in </a:t>
                </a:r>
                <a:r>
                  <a:rPr lang="en-GB" sz="1100" b="1" dirty="0"/>
                  <a:t>ergot resistance phenotypes in the </a:t>
                </a:r>
                <a:r>
                  <a:rPr lang="en-GB" sz="1100" b="1" dirty="0" smtClean="0"/>
                  <a:t>DH </a:t>
                </a:r>
                <a:r>
                  <a:rPr lang="en-GB" sz="1100" b="1" dirty="0"/>
                  <a:t>population derived from the cross </a:t>
                </a:r>
                <a:r>
                  <a:rPr lang="en-GB" sz="1100" b="1" dirty="0" smtClean="0"/>
                  <a:t>Greenshank_RIL3 </a:t>
                </a:r>
                <a:r>
                  <a:rPr lang="en-GB" sz="1100" b="1" dirty="0"/>
                  <a:t>x AC Avonlea. </a:t>
                </a:r>
              </a:p>
              <a:p>
                <a:pPr algn="just"/>
                <a:r>
                  <a:rPr lang="en-GB" sz="1100" dirty="0" smtClean="0"/>
                  <a:t>Ergot resistance screen carried out in (a) Canada and (b) the UK. Honeydew scores were </a:t>
                </a:r>
                <a:r>
                  <a:rPr lang="en-CA" sz="1100" dirty="0"/>
                  <a:t>measured on a 1 to 4 </a:t>
                </a:r>
                <a:r>
                  <a:rPr lang="en-CA" sz="1100" dirty="0" smtClean="0"/>
                  <a:t>scale. Average </a:t>
                </a:r>
                <a:r>
                  <a:rPr lang="en-CA" sz="1100" dirty="0" err="1"/>
                  <a:t>sclerotia</a:t>
                </a:r>
                <a:r>
                  <a:rPr lang="en-CA" sz="1100" dirty="0"/>
                  <a:t> size </a:t>
                </a:r>
                <a:r>
                  <a:rPr lang="en-CA" sz="1100" dirty="0" smtClean="0"/>
                  <a:t>were </a:t>
                </a:r>
                <a:r>
                  <a:rPr lang="en-CA" sz="1100" dirty="0"/>
                  <a:t>measured on a 1-3 </a:t>
                </a:r>
                <a:r>
                  <a:rPr lang="en-CA" sz="1100" dirty="0" smtClean="0"/>
                  <a:t>scale in the Canadian screen and a 1-7 scale in the UK. Average </a:t>
                </a:r>
                <a:r>
                  <a:rPr lang="en-CA" sz="1100" dirty="0" err="1"/>
                  <a:t>sclerotia</a:t>
                </a:r>
                <a:r>
                  <a:rPr lang="en-CA" sz="1100" dirty="0"/>
                  <a:t> </a:t>
                </a:r>
                <a:r>
                  <a:rPr lang="en-CA" sz="1100" dirty="0" smtClean="0"/>
                  <a:t>weight and total </a:t>
                </a:r>
                <a:r>
                  <a:rPr lang="en-CA" sz="1100" dirty="0" err="1" smtClean="0"/>
                  <a:t>sclerotial</a:t>
                </a:r>
                <a:r>
                  <a:rPr lang="en-CA" sz="1100" dirty="0" smtClean="0"/>
                  <a:t> </a:t>
                </a:r>
                <a:r>
                  <a:rPr lang="en-CA" sz="1100" dirty="0"/>
                  <a:t>weight per </a:t>
                </a:r>
                <a:r>
                  <a:rPr lang="en-CA" sz="1100" dirty="0" smtClean="0"/>
                  <a:t>spike are measured in mg. Percentage infection</a:t>
                </a:r>
                <a:r>
                  <a:rPr lang="en-CA" sz="1100" dirty="0"/>
                  <a:t> </a:t>
                </a:r>
                <a:r>
                  <a:rPr lang="en-CA" sz="1100" dirty="0" smtClean="0"/>
                  <a:t>was </a:t>
                </a:r>
                <a:r>
                  <a:rPr lang="en-CA" sz="1100" dirty="0"/>
                  <a:t>assessed as the percentage of </a:t>
                </a:r>
                <a:r>
                  <a:rPr lang="en-CA" sz="1100" i="1" dirty="0"/>
                  <a:t>Claviceps </a:t>
                </a:r>
                <a:r>
                  <a:rPr lang="en-CA" sz="1100" i="1" dirty="0" err="1"/>
                  <a:t>purpuea</a:t>
                </a:r>
                <a:r>
                  <a:rPr lang="en-CA" sz="1100" i="1" dirty="0"/>
                  <a:t> </a:t>
                </a:r>
                <a:r>
                  <a:rPr lang="en-CA" sz="1100" dirty="0"/>
                  <a:t>inoculated </a:t>
                </a:r>
                <a:r>
                  <a:rPr lang="en-CA" sz="1100" dirty="0" smtClean="0"/>
                  <a:t>flowers </a:t>
                </a:r>
                <a:r>
                  <a:rPr lang="en-CA" sz="1100" dirty="0"/>
                  <a:t>that formed a </a:t>
                </a:r>
                <a:r>
                  <a:rPr lang="en-CA" sz="1100" dirty="0" err="1"/>
                  <a:t>sclerotia</a:t>
                </a:r>
                <a:r>
                  <a:rPr lang="en-CA" sz="1100" dirty="0"/>
                  <a:t>. </a:t>
                </a:r>
                <a:r>
                  <a:rPr lang="en-CA" sz="1100" dirty="0" smtClean="0"/>
                  <a:t>Percentage zero was assessed as the percentage of </a:t>
                </a:r>
                <a:r>
                  <a:rPr lang="en-CA" sz="1100" i="1" dirty="0" smtClean="0"/>
                  <a:t>C. </a:t>
                </a:r>
                <a:r>
                  <a:rPr lang="en-CA" sz="1100" i="1" dirty="0" err="1"/>
                  <a:t>purpuea</a:t>
                </a:r>
                <a:r>
                  <a:rPr lang="en-CA" sz="1100" i="1" dirty="0"/>
                  <a:t> </a:t>
                </a:r>
                <a:r>
                  <a:rPr lang="en-CA" sz="1100" dirty="0"/>
                  <a:t>inoculated </a:t>
                </a:r>
                <a:r>
                  <a:rPr lang="en-CA" sz="1100" dirty="0" smtClean="0"/>
                  <a:t>flowers </a:t>
                </a:r>
                <a:r>
                  <a:rPr lang="en-CA" sz="1100" dirty="0"/>
                  <a:t>that </a:t>
                </a:r>
                <a:r>
                  <a:rPr lang="en-CA" sz="1100" dirty="0" smtClean="0"/>
                  <a:t>did not form </a:t>
                </a:r>
                <a:r>
                  <a:rPr lang="en-CA" sz="1100" dirty="0"/>
                  <a:t>a </a:t>
                </a:r>
                <a:r>
                  <a:rPr lang="en-CA" sz="1100" dirty="0" err="1" smtClean="0"/>
                  <a:t>sclerotia</a:t>
                </a:r>
                <a:r>
                  <a:rPr lang="en-CA" sz="1100" dirty="0" smtClean="0"/>
                  <a:t>, leaving only a dried-out ovary. </a:t>
                </a:r>
                <a:r>
                  <a:rPr lang="en-CA" sz="1100" dirty="0"/>
                  <a:t>The </a:t>
                </a:r>
                <a:r>
                  <a:rPr lang="en-CA" sz="1100" dirty="0" smtClean="0"/>
                  <a:t>arrows indicate the average scores of the parental lines Greenshank_RIL3 and AC Avonlea</a:t>
                </a:r>
                <a:r>
                  <a:rPr lang="en-CA" sz="1100" dirty="0" smtClean="0"/>
                  <a:t>. </a:t>
                </a:r>
                <a:r>
                  <a:rPr lang="en-GB" sz="1100" dirty="0"/>
                  <a:t>The y-axis depicts the number of data points per bar.</a:t>
                </a:r>
              </a:p>
              <a:p>
                <a:pPr algn="just"/>
                <a:endParaRPr lang="en-GB" sz="1100" dirty="0"/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447263" y="4465982"/>
                <a:ext cx="5692900" cy="3688471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pSp>
            <p:nvGrpSpPr>
              <p:cNvPr id="29" name="Group 28"/>
              <p:cNvGrpSpPr/>
              <p:nvPr/>
            </p:nvGrpSpPr>
            <p:grpSpPr>
              <a:xfrm>
                <a:off x="2240684" y="2369525"/>
                <a:ext cx="2134498" cy="2134498"/>
                <a:chOff x="1647579" y="7465094"/>
                <a:chExt cx="2134498" cy="2134498"/>
              </a:xfrm>
            </p:grpSpPr>
            <p:pic>
              <p:nvPicPr>
                <p:cNvPr id="33" name="Picture 32"/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1647579" y="7465094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34" name="Isosceles Triangle 33"/>
                <p:cNvSpPr/>
                <p:nvPr/>
              </p:nvSpPr>
              <p:spPr>
                <a:xfrm flipV="1">
                  <a:off x="2460411" y="8804854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5" name="Isosceles Triangle 34"/>
                <p:cNvSpPr/>
                <p:nvPr/>
              </p:nvSpPr>
              <p:spPr>
                <a:xfrm flipV="1">
                  <a:off x="2705973" y="8852927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6" name="Rectangle 35"/>
                <p:cNvSpPr/>
                <p:nvPr/>
              </p:nvSpPr>
              <p:spPr>
                <a:xfrm>
                  <a:off x="2382552" y="8641953"/>
                  <a:ext cx="635593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960B-173A: 32.27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Rectangle 36"/>
                <p:cNvSpPr/>
                <p:nvPr/>
              </p:nvSpPr>
              <p:spPr>
                <a:xfrm>
                  <a:off x="2631971" y="8724179"/>
                  <a:ext cx="506126" cy="1640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5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5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51.3</a:t>
                  </a:r>
                  <a:endParaRPr lang="en-GB" sz="5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38" name="Picture 37"/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1790702" y="7608217"/>
                  <a:ext cx="1991375" cy="1991375"/>
                </a:xfrm>
                <a:prstGeom prst="rect">
                  <a:avLst/>
                </a:prstGeom>
              </p:spPr>
            </p:pic>
            <p:sp>
              <p:nvSpPr>
                <p:cNvPr id="39" name="Isosceles Triangle 38"/>
                <p:cNvSpPr/>
                <p:nvPr/>
              </p:nvSpPr>
              <p:spPr>
                <a:xfrm flipV="1">
                  <a:off x="2603535" y="8947978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0" name="Isosceles Triangle 39"/>
                <p:cNvSpPr/>
                <p:nvPr/>
              </p:nvSpPr>
              <p:spPr>
                <a:xfrm flipV="1">
                  <a:off x="2849097" y="8996050"/>
                  <a:ext cx="44476" cy="65005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1" name="Rectangle 40"/>
                <p:cNvSpPr/>
                <p:nvPr/>
              </p:nvSpPr>
              <p:spPr>
                <a:xfrm>
                  <a:off x="2525676" y="8785076"/>
                  <a:ext cx="771365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reenshank: 32.27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Rectangle 41"/>
                <p:cNvSpPr/>
                <p:nvPr/>
              </p:nvSpPr>
              <p:spPr>
                <a:xfrm>
                  <a:off x="2775095" y="8859929"/>
                  <a:ext cx="611065" cy="18678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GB" sz="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vonlea: </a:t>
                  </a:r>
                  <a:r>
                    <a:rPr lang="en-GB" sz="600" dirty="0" smtClean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51.3</a:t>
                  </a:r>
                  <a:endParaRPr lang="en-GB" sz="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0" name="Rectangle 29"/>
              <p:cNvSpPr/>
              <p:nvPr/>
            </p:nvSpPr>
            <p:spPr>
              <a:xfrm>
                <a:off x="447263" y="594474"/>
                <a:ext cx="5692900" cy="3867365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27384" y="568257"/>
                <a:ext cx="2712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a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29245" y="4418371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b</a:t>
                </a:r>
              </a:p>
            </p:txBody>
          </p:sp>
        </p:grpSp>
        <p:sp>
          <p:nvSpPr>
            <p:cNvPr id="6" name="Rectangle 5"/>
            <p:cNvSpPr/>
            <p:nvPr/>
          </p:nvSpPr>
          <p:spPr>
            <a:xfrm>
              <a:off x="695697" y="581401"/>
              <a:ext cx="1665883" cy="1249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Honeydew scale 1-4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738045" y="4421689"/>
              <a:ext cx="1665883" cy="1249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Honeydew scale 1-4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2646943" y="605611"/>
              <a:ext cx="1665883" cy="1249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Average </a:t>
              </a:r>
              <a:r>
                <a:rPr lang="en-GB" sz="800" dirty="0" err="1" smtClean="0">
                  <a:solidFill>
                    <a:schemeClr val="tx1"/>
                  </a:solidFill>
                </a:rPr>
                <a:t>Sclerotia</a:t>
              </a:r>
              <a:r>
                <a:rPr lang="en-GB" sz="800" dirty="0" smtClean="0">
                  <a:solidFill>
                    <a:schemeClr val="tx1"/>
                  </a:solidFill>
                </a:rPr>
                <a:t> size (1-3 scale)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4509434" y="628807"/>
              <a:ext cx="1600911" cy="11266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Average </a:t>
              </a:r>
              <a:r>
                <a:rPr lang="en-GB" sz="800" dirty="0" err="1" smtClean="0">
                  <a:solidFill>
                    <a:schemeClr val="tx1"/>
                  </a:solidFill>
                </a:rPr>
                <a:t>Sclerotia</a:t>
              </a:r>
              <a:r>
                <a:rPr lang="en-GB" sz="800" dirty="0" smtClean="0">
                  <a:solidFill>
                    <a:schemeClr val="tx1"/>
                  </a:solidFill>
                </a:rPr>
                <a:t> </a:t>
              </a:r>
              <a:r>
                <a:rPr lang="en-GB" sz="800" dirty="0" smtClean="0">
                  <a:solidFill>
                    <a:schemeClr val="tx1"/>
                  </a:solidFill>
                </a:rPr>
                <a:t>weight / mg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2633241" y="4451475"/>
              <a:ext cx="1665883" cy="1249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Average </a:t>
              </a:r>
              <a:r>
                <a:rPr lang="en-GB" sz="800" dirty="0" err="1" smtClean="0">
                  <a:solidFill>
                    <a:schemeClr val="tx1"/>
                  </a:solidFill>
                </a:rPr>
                <a:t>Sclerotia</a:t>
              </a:r>
              <a:r>
                <a:rPr lang="en-GB" sz="800" dirty="0" smtClean="0">
                  <a:solidFill>
                    <a:schemeClr val="tx1"/>
                  </a:solidFill>
                </a:rPr>
                <a:t> size (0-7 scale)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572486" y="4478359"/>
              <a:ext cx="1527897" cy="1173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Average </a:t>
              </a:r>
              <a:r>
                <a:rPr lang="en-GB" sz="800" dirty="0" err="1" smtClean="0">
                  <a:solidFill>
                    <a:schemeClr val="tx1"/>
                  </a:solidFill>
                </a:rPr>
                <a:t>Sclerotia</a:t>
              </a:r>
              <a:r>
                <a:rPr lang="en-GB" sz="800" dirty="0" smtClean="0">
                  <a:solidFill>
                    <a:schemeClr val="tx1"/>
                  </a:solidFill>
                </a:rPr>
                <a:t> </a:t>
              </a:r>
              <a:r>
                <a:rPr lang="en-GB" sz="800" dirty="0" smtClean="0">
                  <a:solidFill>
                    <a:schemeClr val="tx1"/>
                  </a:solidFill>
                </a:rPr>
                <a:t>weight / mg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677221" y="6259866"/>
              <a:ext cx="1757666" cy="1649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Total </a:t>
              </a:r>
              <a:r>
                <a:rPr lang="en-GB" sz="800" dirty="0" err="1" smtClean="0">
                  <a:solidFill>
                    <a:schemeClr val="tx1"/>
                  </a:solidFill>
                </a:rPr>
                <a:t>Sclerotial</a:t>
              </a:r>
              <a:r>
                <a:rPr lang="en-GB" sz="800" dirty="0" smtClean="0">
                  <a:solidFill>
                    <a:schemeClr val="tx1"/>
                  </a:solidFill>
                </a:rPr>
                <a:t> weight per </a:t>
              </a:r>
              <a:r>
                <a:rPr lang="en-GB" sz="800" dirty="0" smtClean="0">
                  <a:solidFill>
                    <a:schemeClr val="tx1"/>
                  </a:solidFill>
                </a:rPr>
                <a:t>spike / mg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46002" y="2564655"/>
              <a:ext cx="1836581" cy="1517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Total </a:t>
              </a:r>
              <a:r>
                <a:rPr lang="en-GB" sz="800" dirty="0" err="1" smtClean="0">
                  <a:solidFill>
                    <a:schemeClr val="tx1"/>
                  </a:solidFill>
                </a:rPr>
                <a:t>Sclerotial</a:t>
              </a:r>
              <a:r>
                <a:rPr lang="en-GB" sz="800" dirty="0" smtClean="0">
                  <a:solidFill>
                    <a:schemeClr val="tx1"/>
                  </a:solidFill>
                </a:rPr>
                <a:t> weight per </a:t>
              </a:r>
              <a:r>
                <a:rPr lang="en-GB" sz="800" dirty="0" smtClean="0">
                  <a:solidFill>
                    <a:schemeClr val="tx1"/>
                  </a:solidFill>
                </a:rPr>
                <a:t>spike / mg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2720493" y="2568307"/>
              <a:ext cx="1665883" cy="1249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Percentage infected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676619" y="6279458"/>
              <a:ext cx="1665883" cy="1249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Percentage infected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4579333" y="6263417"/>
              <a:ext cx="1404359" cy="15537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800" dirty="0" smtClean="0">
                  <a:solidFill>
                    <a:schemeClr val="tx1"/>
                  </a:solidFill>
                </a:rPr>
                <a:t>Percentage scoring zero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83231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335</Words>
  <Application>Microsoft Office PowerPoint</Application>
  <PresentationFormat>A4 Paper (210x297 mm)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Gordon</dc:creator>
  <cp:lastModifiedBy>Anna Gordon</cp:lastModifiedBy>
  <cp:revision>2</cp:revision>
  <dcterms:created xsi:type="dcterms:W3CDTF">2019-10-29T12:42:48Z</dcterms:created>
  <dcterms:modified xsi:type="dcterms:W3CDTF">2020-02-07T11:02:20Z</dcterms:modified>
</cp:coreProperties>
</file>